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9643" autoAdjust="0"/>
  </p:normalViewPr>
  <p:slideViewPr>
    <p:cSldViewPr snapToGrid="0">
      <p:cViewPr varScale="1">
        <p:scale>
          <a:sx n="65" d="100"/>
          <a:sy n="65" d="100"/>
        </p:scale>
        <p:origin x="-948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FD1CA1-CAF3-4E28-BDC3-D0B4A5A14DF2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87C0E8-B7CA-4464-830E-37F472C54B3D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4231320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Wingdings" panose="05000000000000000000" pitchFamily="2" charset="2"/>
              <a:buChar char="à"/>
            </a:pPr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87C0E8-B7CA-4464-830E-37F472C54B3D}" type="slidenum">
              <a:rPr lang="en-SG" smtClean="0"/>
              <a:pPr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1056354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3950784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353764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3039514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1571097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42462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710470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1665580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874924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686085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803388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249013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26B2D-6C1B-492E-A2C0-7B35BF1C5C71}" type="datetimeFigureOut">
              <a:rPr lang="en-SG" smtClean="0"/>
              <a:pPr/>
              <a:t>14/12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637DC-DD69-446D-971E-99F56CC73E88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2669686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4517567" y="3408307"/>
            <a:ext cx="20627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Total S6-riboprotein</a:t>
            </a:r>
            <a:endParaRPr lang="en-SG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4439203" y="3019619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hospho-S6 S235/236</a:t>
            </a:r>
            <a:endParaRPr lang="en-SG" sz="1600" dirty="0"/>
          </a:p>
        </p:txBody>
      </p:sp>
      <p:sp>
        <p:nvSpPr>
          <p:cNvPr id="23" name="TextBox 22"/>
          <p:cNvSpPr txBox="1"/>
          <p:nvPr/>
        </p:nvSpPr>
        <p:spPr>
          <a:xfrm>
            <a:off x="1892798" y="1196186"/>
            <a:ext cx="1316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 0    </a:t>
            </a:r>
            <a:r>
              <a:rPr lang="en-US" sz="1400" dirty="0"/>
              <a:t> </a:t>
            </a:r>
            <a:r>
              <a:rPr lang="en-US" sz="1400" dirty="0" smtClean="0"/>
              <a:t>1      5     25    </a:t>
            </a:r>
            <a:endParaRPr lang="en-SG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1892798" y="917610"/>
            <a:ext cx="254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2-D culture</a:t>
            </a:r>
            <a:endParaRPr lang="en-SG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662189" y="1186855"/>
            <a:ext cx="21273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/>
              <a:t>Sorafenib</a:t>
            </a:r>
            <a:r>
              <a:rPr lang="en-US" sz="1400" dirty="0" smtClean="0"/>
              <a:t> 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en-US" sz="1400" dirty="0" smtClean="0"/>
              <a:t>M)</a:t>
            </a:r>
            <a:br>
              <a:rPr lang="en-US" sz="1400" dirty="0" smtClean="0"/>
            </a:br>
            <a:r>
              <a:rPr lang="en-US" sz="1400" dirty="0" smtClean="0"/>
              <a:t>Rapamycin (</a:t>
            </a:r>
            <a:r>
              <a:rPr lang="en-US" sz="1400" dirty="0" err="1" smtClean="0"/>
              <a:t>nM</a:t>
            </a:r>
            <a:r>
              <a:rPr lang="en-US" sz="1400" dirty="0" smtClean="0"/>
              <a:t>)</a:t>
            </a:r>
            <a:endParaRPr lang="en-SG" sz="1400" dirty="0"/>
          </a:p>
        </p:txBody>
      </p:sp>
      <p:sp>
        <p:nvSpPr>
          <p:cNvPr id="29" name="TextBox 28"/>
          <p:cNvSpPr txBox="1"/>
          <p:nvPr/>
        </p:nvSpPr>
        <p:spPr>
          <a:xfrm>
            <a:off x="2680903" y="702941"/>
            <a:ext cx="1144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iaPaCa-2</a:t>
            </a:r>
            <a:endParaRPr lang="en-SG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4510335" y="2512908"/>
            <a:ext cx="20627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Total p70-S6 Kinase</a:t>
            </a:r>
            <a:endParaRPr lang="en-SG" sz="1600" dirty="0"/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805" t="12197" r="32250" b="75853"/>
          <a:stretch/>
        </p:blipFill>
        <p:spPr>
          <a:xfrm flipH="1">
            <a:off x="1872490" y="1828801"/>
            <a:ext cx="2607146" cy="494458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3164684" y="1415222"/>
            <a:ext cx="1413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 0    10    50  250</a:t>
            </a:r>
            <a:endParaRPr lang="en-SG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4360031" y="1925018"/>
            <a:ext cx="24094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hospho-S6K T421/424</a:t>
            </a:r>
            <a:endParaRPr lang="en-SG" sz="1600" dirty="0"/>
          </a:p>
        </p:txBody>
      </p:sp>
      <p:sp>
        <p:nvSpPr>
          <p:cNvPr id="57" name="TextBox 56"/>
          <p:cNvSpPr txBox="1"/>
          <p:nvPr/>
        </p:nvSpPr>
        <p:spPr>
          <a:xfrm>
            <a:off x="6768030" y="1192553"/>
            <a:ext cx="1316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 0    </a:t>
            </a:r>
            <a:r>
              <a:rPr lang="en-US" sz="1400" dirty="0"/>
              <a:t> </a:t>
            </a:r>
            <a:r>
              <a:rPr lang="en-US" sz="1400" dirty="0" smtClean="0"/>
              <a:t>1      5     25    </a:t>
            </a:r>
            <a:endParaRPr lang="en-SG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6768030" y="913977"/>
            <a:ext cx="25464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3</a:t>
            </a:r>
            <a:r>
              <a:rPr lang="en-US" sz="1400" dirty="0" smtClean="0"/>
              <a:t>-D culture</a:t>
            </a:r>
            <a:endParaRPr lang="en-SG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5537421" y="1183222"/>
            <a:ext cx="21273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/>
              <a:t>Sorafenib</a:t>
            </a:r>
            <a:r>
              <a:rPr lang="en-US" sz="1400" dirty="0" smtClean="0"/>
              <a:t> 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en-US" sz="1400" dirty="0" smtClean="0"/>
              <a:t>M)</a:t>
            </a:r>
            <a:br>
              <a:rPr lang="en-US" sz="1400" dirty="0" smtClean="0"/>
            </a:br>
            <a:r>
              <a:rPr lang="en-US" sz="1400" dirty="0" smtClean="0"/>
              <a:t>Rapamycin (</a:t>
            </a:r>
            <a:r>
              <a:rPr lang="en-US" sz="1400" dirty="0" err="1" smtClean="0"/>
              <a:t>nM</a:t>
            </a:r>
            <a:r>
              <a:rPr lang="en-US" sz="1400" dirty="0" smtClean="0"/>
              <a:t>)</a:t>
            </a:r>
            <a:endParaRPr lang="en-SG" sz="1400" dirty="0"/>
          </a:p>
        </p:txBody>
      </p:sp>
      <p:sp>
        <p:nvSpPr>
          <p:cNvPr id="60" name="TextBox 59"/>
          <p:cNvSpPr txBox="1"/>
          <p:nvPr/>
        </p:nvSpPr>
        <p:spPr>
          <a:xfrm>
            <a:off x="7556135" y="699308"/>
            <a:ext cx="1144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iaPaCa-2</a:t>
            </a:r>
            <a:endParaRPr lang="en-SG" sz="1400" dirty="0"/>
          </a:p>
        </p:txBody>
      </p:sp>
      <p:sp>
        <p:nvSpPr>
          <p:cNvPr id="61" name="TextBox 60"/>
          <p:cNvSpPr txBox="1"/>
          <p:nvPr/>
        </p:nvSpPr>
        <p:spPr>
          <a:xfrm>
            <a:off x="8291842" y="1412697"/>
            <a:ext cx="1413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 0    10    50  250</a:t>
            </a:r>
            <a:endParaRPr lang="en-SG" sz="1400" dirty="0"/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50995" t="81666" r="19772" b="4268"/>
          <a:stretch/>
        </p:blipFill>
        <p:spPr>
          <a:xfrm rot="180000" flipH="1">
            <a:off x="6776630" y="2490836"/>
            <a:ext cx="989044" cy="354565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5155" t="58938" r="3008" b="24527"/>
          <a:stretch/>
        </p:blipFill>
        <p:spPr>
          <a:xfrm rot="120000" flipH="1">
            <a:off x="6751648" y="1861955"/>
            <a:ext cx="2897128" cy="416809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4281" t="48884" r="12393" b="39907"/>
          <a:stretch/>
        </p:blipFill>
        <p:spPr>
          <a:xfrm flipH="1">
            <a:off x="1828125" y="3386421"/>
            <a:ext cx="2708104" cy="398368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4763" t="30166" r="12546" b="58108"/>
          <a:stretch/>
        </p:blipFill>
        <p:spPr>
          <a:xfrm flipH="1">
            <a:off x="1782148" y="3032447"/>
            <a:ext cx="2715205" cy="391885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876" t="29700" r="8088" b="57158"/>
          <a:stretch/>
        </p:blipFill>
        <p:spPr>
          <a:xfrm flipH="1">
            <a:off x="6723650" y="3060441"/>
            <a:ext cx="2961526" cy="317237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4427204" y="3853300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hospho-Erk1/2</a:t>
            </a:r>
            <a:endParaRPr lang="en-SG" sz="1600" dirty="0"/>
          </a:p>
        </p:txBody>
      </p:sp>
      <p:sp>
        <p:nvSpPr>
          <p:cNvPr id="69" name="TextBox 68"/>
          <p:cNvSpPr txBox="1"/>
          <p:nvPr/>
        </p:nvSpPr>
        <p:spPr>
          <a:xfrm>
            <a:off x="4439203" y="4229611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Total-Erk1/2</a:t>
            </a:r>
            <a:endParaRPr lang="en-SG" sz="1600" dirty="0"/>
          </a:p>
        </p:txBody>
      </p:sp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4612" t="77947" r="15471" b="13169"/>
          <a:stretch/>
        </p:blipFill>
        <p:spPr>
          <a:xfrm rot="-60000" flipH="1">
            <a:off x="1828123" y="3862931"/>
            <a:ext cx="2708105" cy="386184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518" t="48334" r="12401" b="37600"/>
          <a:stretch/>
        </p:blipFill>
        <p:spPr>
          <a:xfrm rot="-60000" flipH="1">
            <a:off x="6755291" y="3874284"/>
            <a:ext cx="2900830" cy="354564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>
            <a:off x="4439202" y="4932109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an-</a:t>
            </a:r>
            <a:r>
              <a:rPr lang="en-US" sz="1600" dirty="0" err="1" smtClean="0"/>
              <a:t>Ras</a:t>
            </a:r>
            <a:endParaRPr lang="en-SG" sz="1600" dirty="0"/>
          </a:p>
        </p:txBody>
      </p:sp>
      <p:sp>
        <p:nvSpPr>
          <p:cNvPr id="73" name="TextBox 72"/>
          <p:cNvSpPr txBox="1"/>
          <p:nvPr/>
        </p:nvSpPr>
        <p:spPr>
          <a:xfrm>
            <a:off x="4439202" y="4565904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p21</a:t>
            </a:r>
            <a:endParaRPr lang="en-SG" sz="1600" dirty="0"/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0407" t="66814" r="27707" b="23523"/>
          <a:stretch/>
        </p:blipFill>
        <p:spPr>
          <a:xfrm flipH="1">
            <a:off x="1861111" y="4575235"/>
            <a:ext cx="2607146" cy="289997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431" t="38639" r="8517" b="49379"/>
          <a:stretch/>
        </p:blipFill>
        <p:spPr>
          <a:xfrm flipH="1">
            <a:off x="6733755" y="4573010"/>
            <a:ext cx="2921412" cy="28925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631" t="56409" r="8626" b="31730"/>
          <a:stretch/>
        </p:blipFill>
        <p:spPr>
          <a:xfrm flipH="1">
            <a:off x="6742942" y="4279576"/>
            <a:ext cx="2942234" cy="2863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6602" t="23504" r="22893" b="66165"/>
          <a:stretch/>
        </p:blipFill>
        <p:spPr>
          <a:xfrm flipH="1">
            <a:off x="1881724" y="4202566"/>
            <a:ext cx="2615629" cy="3071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914" t="46844" r="5488" b="41295"/>
          <a:stretch/>
        </p:blipFill>
        <p:spPr>
          <a:xfrm flipH="1">
            <a:off x="6702321" y="5011987"/>
            <a:ext cx="2952845" cy="286327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5180" t="17797" r="13459" b="72255"/>
          <a:stretch/>
        </p:blipFill>
        <p:spPr>
          <a:xfrm flipH="1">
            <a:off x="1861111" y="4944368"/>
            <a:ext cx="2578090" cy="36781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058" t="48374" r="6343" b="39765"/>
          <a:stretch/>
        </p:blipFill>
        <p:spPr>
          <a:xfrm flipH="1">
            <a:off x="6733754" y="3445307"/>
            <a:ext cx="2951421" cy="28632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6317" t="45313" r="24890" b="43591"/>
          <a:stretch/>
        </p:blipFill>
        <p:spPr>
          <a:xfrm flipH="1">
            <a:off x="1861111" y="2474624"/>
            <a:ext cx="2578090" cy="42412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485" t="63678" r="52568" b="24460"/>
          <a:stretch/>
        </p:blipFill>
        <p:spPr>
          <a:xfrm flipH="1">
            <a:off x="8291841" y="2563958"/>
            <a:ext cx="1363324" cy="28632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8885" t="64061" r="19183" b="27139"/>
          <a:stretch/>
        </p:blipFill>
        <p:spPr>
          <a:xfrm flipH="1">
            <a:off x="1782147" y="5417940"/>
            <a:ext cx="2673579" cy="327892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268" t="73817" r="7273" b="16617"/>
          <a:stretch/>
        </p:blipFill>
        <p:spPr>
          <a:xfrm flipH="1">
            <a:off x="6742941" y="5514922"/>
            <a:ext cx="2912222" cy="23091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4427203" y="5344475"/>
            <a:ext cx="22751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/>
              <a:t>Beta-actin</a:t>
            </a:r>
            <a:endParaRPr lang="en-SG" sz="1600" dirty="0"/>
          </a:p>
        </p:txBody>
      </p:sp>
    </p:spTree>
    <p:extLst>
      <p:ext uri="{BB962C8B-B14F-4D97-AF65-F5344CB8AC3E}">
        <p14:creationId xmlns:p14="http://schemas.microsoft.com/office/powerpoint/2010/main" xmlns="" val="1044172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</TotalTime>
  <Words>49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 Hiu Yeung</dc:creator>
  <cp:lastModifiedBy>Hiu Yeung</cp:lastModifiedBy>
  <cp:revision>23</cp:revision>
  <dcterms:created xsi:type="dcterms:W3CDTF">2016-07-19T04:41:23Z</dcterms:created>
  <dcterms:modified xsi:type="dcterms:W3CDTF">2020-12-14T00:15:51Z</dcterms:modified>
</cp:coreProperties>
</file>